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8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54" userDrawn="1">
          <p15:clr>
            <a:srgbClr val="A4A3A4"/>
          </p15:clr>
        </p15:guide>
        <p15:guide id="2" pos="13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864"/>
    <p:restoredTop sz="74859"/>
  </p:normalViewPr>
  <p:slideViewPr>
    <p:cSldViewPr snapToGrid="0">
      <p:cViewPr varScale="1">
        <p:scale>
          <a:sx n="61" d="100"/>
          <a:sy n="61" d="100"/>
        </p:scale>
        <p:origin x="3560" y="232"/>
      </p:cViewPr>
      <p:guideLst>
        <p:guide orient="horz" pos="1354"/>
        <p:guide pos="135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4488C1-06E0-8446-97C2-2573888604F2}" type="datetimeFigureOut">
              <a:rPr lang="en-US" smtClean="0"/>
              <a:t>9/28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85CD4A-AC4B-C34F-A2DB-EB3D5893F9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15872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20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102" algn="l" defTabSz="91420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203" algn="l" defTabSz="91420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305" algn="l" defTabSz="91420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407" algn="l" defTabSz="91420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508" algn="l" defTabSz="91420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610" algn="l" defTabSz="91420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199711" algn="l" defTabSz="91420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6813" algn="l" defTabSz="91420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685CD4A-AC4B-C34F-A2DB-EB3D5893F9E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95621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3E00F-135D-5A42-8028-4945EC8A063D}" type="datetimeFigureOut">
              <a:rPr lang="en-US" smtClean="0"/>
              <a:t>9/2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E7C46-9056-4045-B414-20B75046A4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18358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3E00F-135D-5A42-8028-4945EC8A063D}" type="datetimeFigureOut">
              <a:rPr lang="en-US" smtClean="0"/>
              <a:t>9/2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E7C46-9056-4045-B414-20B75046A4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69113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3E00F-135D-5A42-8028-4945EC8A063D}" type="datetimeFigureOut">
              <a:rPr lang="en-US" smtClean="0"/>
              <a:t>9/2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E7C46-9056-4045-B414-20B75046A4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4222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3E00F-135D-5A42-8028-4945EC8A063D}" type="datetimeFigureOut">
              <a:rPr lang="en-US" smtClean="0"/>
              <a:t>9/2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E7C46-9056-4045-B414-20B75046A4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09718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3E00F-135D-5A42-8028-4945EC8A063D}" type="datetimeFigureOut">
              <a:rPr lang="en-US" smtClean="0"/>
              <a:t>9/2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E7C46-9056-4045-B414-20B75046A4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99735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3E00F-135D-5A42-8028-4945EC8A063D}" type="datetimeFigureOut">
              <a:rPr lang="en-US" smtClean="0"/>
              <a:t>9/2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E7C46-9056-4045-B414-20B75046A4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95167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3E00F-135D-5A42-8028-4945EC8A063D}" type="datetimeFigureOut">
              <a:rPr lang="en-US" smtClean="0"/>
              <a:t>9/28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E7C46-9056-4045-B414-20B75046A4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89577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3E00F-135D-5A42-8028-4945EC8A063D}" type="datetimeFigureOut">
              <a:rPr lang="en-US" smtClean="0"/>
              <a:t>9/28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E7C46-9056-4045-B414-20B75046A4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6411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3E00F-135D-5A42-8028-4945EC8A063D}" type="datetimeFigureOut">
              <a:rPr lang="en-US" smtClean="0"/>
              <a:t>9/28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E7C46-9056-4045-B414-20B75046A4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955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3E00F-135D-5A42-8028-4945EC8A063D}" type="datetimeFigureOut">
              <a:rPr lang="en-US" smtClean="0"/>
              <a:t>9/2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E7C46-9056-4045-B414-20B75046A4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54123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3E00F-135D-5A42-8028-4945EC8A063D}" type="datetimeFigureOut">
              <a:rPr lang="en-US" smtClean="0"/>
              <a:t>9/2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E7C46-9056-4045-B414-20B75046A4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5564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A3E00F-135D-5A42-8028-4945EC8A063D}" type="datetimeFigureOut">
              <a:rPr lang="en-US" smtClean="0"/>
              <a:t>9/2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6E7C46-9056-4045-B414-20B75046A4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39769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E7970891-E7DD-E6C3-6EB8-0DCBC2B14562}"/>
              </a:ext>
            </a:extLst>
          </p:cNvPr>
          <p:cNvSpPr txBox="1"/>
          <p:nvPr/>
        </p:nvSpPr>
        <p:spPr>
          <a:xfrm>
            <a:off x="135733" y="5775410"/>
            <a:ext cx="7429500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CA" sz="12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Fig. 1: Intracerebral Inoculation with Reovirus T3D at Post-Natal Day 3 Does Not Uncover Genotypic Differences in Time-To-Death Between Wild-Type, Heterozygous, or Homozygous Lrrk2 p.D1994S Mutant Mice. </a:t>
            </a:r>
            <a:r>
              <a:rPr lang="en-CA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eterozygous Lrrk2 p.D1994S-carrying breeders were paired</a:t>
            </a:r>
            <a:r>
              <a:rPr lang="en-CA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 At </a:t>
            </a:r>
            <a:r>
              <a:rPr lang="en-CA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ost-natal day 3 mice were inoculated with a dose of 5x10</a:t>
            </a:r>
            <a:r>
              <a:rPr lang="en-CA" sz="12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2</a:t>
            </a:r>
            <a:r>
              <a:rPr lang="en-CA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PFU of reovirus T3D via direct-brain injection into the left hemisphere and monitored for time-to-death.  Inoculated pups were monitored over 14 days for a pre-determined moribund state. Time-to-death is graphically displayed as percent survival against days post inoculation (DPI), separated based on sex </a:t>
            </a:r>
            <a:r>
              <a:rPr lang="en-CA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(a)</a:t>
            </a:r>
            <a:r>
              <a:rPr lang="en-CA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 The </a:t>
            </a:r>
            <a:r>
              <a:rPr lang="en-CA" sz="12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n </a:t>
            </a:r>
            <a:r>
              <a:rPr lang="en-CA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value indicates the sample size of sexes combined. Survival curves were statistically analyzed using Mantel-Cox (Log-Rank) tests. No significant group differences were observed.</a:t>
            </a:r>
          </a:p>
          <a:p>
            <a:pPr algn="just"/>
            <a:endParaRPr lang="en-CA" sz="1200" kern="100" dirty="0">
              <a:solidFill>
                <a:srgbClr val="000000"/>
              </a:solidFill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algn="just"/>
            <a:endParaRPr lang="en-CA" sz="1200" kern="100" dirty="0"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1416E402-045D-1E6D-C4BB-593C32590026}"/>
              </a:ext>
            </a:extLst>
          </p:cNvPr>
          <p:cNvGrpSpPr>
            <a:grpSpLocks noChangeAspect="1"/>
          </p:cNvGrpSpPr>
          <p:nvPr/>
        </p:nvGrpSpPr>
        <p:grpSpPr>
          <a:xfrm>
            <a:off x="670855" y="2650733"/>
            <a:ext cx="6987560" cy="2954103"/>
            <a:chOff x="2567476" y="2300404"/>
            <a:chExt cx="4085159" cy="1727066"/>
          </a:xfrm>
        </p:grpSpPr>
        <p:pic>
          <p:nvPicPr>
            <p:cNvPr id="8" name="Content Placeholder 8" descr="A close up of a map&#10;&#10;Description automatically generated">
              <a:extLst>
                <a:ext uri="{FF2B5EF4-FFF2-40B4-BE49-F238E27FC236}">
                  <a16:creationId xmlns:a16="http://schemas.microsoft.com/office/drawing/2014/main" id="{4B200FAD-9F0C-74DE-B8DD-0308A427D63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34204" t="27300" b="13228"/>
            <a:stretch/>
          </p:blipFill>
          <p:spPr>
            <a:xfrm>
              <a:off x="2567476" y="2300404"/>
              <a:ext cx="3729005" cy="1727066"/>
            </a:xfrm>
            <a:prstGeom prst="rect">
              <a:avLst/>
            </a:prstGeom>
          </p:spPr>
        </p:pic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2DCE2D26-B6BB-66D8-E567-206E4408EBA5}"/>
                </a:ext>
              </a:extLst>
            </p:cNvPr>
            <p:cNvGrpSpPr/>
            <p:nvPr/>
          </p:nvGrpSpPr>
          <p:grpSpPr>
            <a:xfrm>
              <a:off x="5607139" y="2891396"/>
              <a:ext cx="1045496" cy="609600"/>
              <a:chOff x="6572907" y="2891396"/>
              <a:chExt cx="1045496" cy="609600"/>
            </a:xfrm>
          </p:grpSpPr>
          <p:pic>
            <p:nvPicPr>
              <p:cNvPr id="12" name="Picture 11" descr="A group of black and white text&#10;&#10;Description automatically generated">
                <a:extLst>
                  <a:ext uri="{FF2B5EF4-FFF2-40B4-BE49-F238E27FC236}">
                    <a16:creationId xmlns:a16="http://schemas.microsoft.com/office/drawing/2014/main" id="{6D654AE7-0550-F592-5317-6F38DD79930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r="37644"/>
              <a:stretch/>
            </p:blipFill>
            <p:spPr>
              <a:xfrm>
                <a:off x="6572907" y="2891396"/>
                <a:ext cx="688974" cy="609600"/>
              </a:xfrm>
              <a:prstGeom prst="rect">
                <a:avLst/>
              </a:prstGeom>
            </p:spPr>
          </p:pic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A614BAF6-6C17-BBC3-DF43-72A244410029}"/>
                  </a:ext>
                </a:extLst>
              </p:cNvPr>
              <p:cNvSpPr txBox="1"/>
              <p:nvPr/>
            </p:nvSpPr>
            <p:spPr>
              <a:xfrm>
                <a:off x="7261879" y="2938565"/>
                <a:ext cx="299689" cy="1860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73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n=9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1A129F0E-5689-A972-6AA1-1EEEF04D497B}"/>
                  </a:ext>
                </a:extLst>
              </p:cNvPr>
              <p:cNvSpPr txBox="1"/>
              <p:nvPr/>
            </p:nvSpPr>
            <p:spPr>
              <a:xfrm>
                <a:off x="7261879" y="3086659"/>
                <a:ext cx="299689" cy="1860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73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n=7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9B9C84A5-A919-548E-1048-97ACBCB11FC2}"/>
                  </a:ext>
                </a:extLst>
              </p:cNvPr>
              <p:cNvSpPr txBox="1"/>
              <p:nvPr/>
            </p:nvSpPr>
            <p:spPr>
              <a:xfrm>
                <a:off x="7261880" y="3235835"/>
                <a:ext cx="356523" cy="1860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73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n=10</a:t>
                </a:r>
              </a:p>
            </p:txBody>
          </p:sp>
        </p:grp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4234A7CA-D07B-DE27-1805-1566FC432498}"/>
              </a:ext>
            </a:extLst>
          </p:cNvPr>
          <p:cNvSpPr txBox="1"/>
          <p:nvPr/>
        </p:nvSpPr>
        <p:spPr>
          <a:xfrm>
            <a:off x="5347809" y="125412"/>
            <a:ext cx="23106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Figure 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FE46518-9F7D-1C90-AC90-65862AB69C82}"/>
              </a:ext>
            </a:extLst>
          </p:cNvPr>
          <p:cNvSpPr txBox="1"/>
          <p:nvPr/>
        </p:nvSpPr>
        <p:spPr>
          <a:xfrm>
            <a:off x="1987744" y="5344392"/>
            <a:ext cx="465191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b="1" dirty="0">
                <a:latin typeface="Arial" panose="020B0604020202020204" pitchFamily="34" charset="0"/>
                <a:cs typeface="Arial" panose="020B0604020202020204" pitchFamily="34" charset="0"/>
              </a:rPr>
              <a:t>DPI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8E3D3FC-3501-4D4B-8C2E-39CA677AD00D}"/>
              </a:ext>
            </a:extLst>
          </p:cNvPr>
          <p:cNvSpPr txBox="1"/>
          <p:nvPr/>
        </p:nvSpPr>
        <p:spPr>
          <a:xfrm>
            <a:off x="4744655" y="5344392"/>
            <a:ext cx="465191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b="1" dirty="0">
                <a:latin typeface="Arial" panose="020B0604020202020204" pitchFamily="34" charset="0"/>
                <a:cs typeface="Arial" panose="020B0604020202020204" pitchFamily="34" charset="0"/>
              </a:rPr>
              <a:t>DPI</a:t>
            </a:r>
          </a:p>
        </p:txBody>
      </p:sp>
    </p:spTree>
    <p:extLst>
      <p:ext uri="{BB962C8B-B14F-4D97-AF65-F5344CB8AC3E}">
        <p14:creationId xmlns:p14="http://schemas.microsoft.com/office/powerpoint/2010/main" val="4251136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908</TotalTime>
  <Words>151</Words>
  <Application>Microsoft Macintosh PowerPoint</Application>
  <PresentationFormat>Custom</PresentationFormat>
  <Paragraphs>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2013 - 2022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a Lunn</dc:creator>
  <cp:lastModifiedBy>Michaela Lunn</cp:lastModifiedBy>
  <cp:revision>127</cp:revision>
  <dcterms:created xsi:type="dcterms:W3CDTF">2023-01-13T15:49:07Z</dcterms:created>
  <dcterms:modified xsi:type="dcterms:W3CDTF">2024-09-28T14:31:13Z</dcterms:modified>
</cp:coreProperties>
</file>